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35" autoAdjust="0"/>
    <p:restoredTop sz="94660"/>
  </p:normalViewPr>
  <p:slideViewPr>
    <p:cSldViewPr snapToGrid="0">
      <p:cViewPr varScale="1">
        <p:scale>
          <a:sx n="71" d="100"/>
          <a:sy n="71" d="100"/>
        </p:scale>
        <p:origin x="4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3734AE-5CFC-4C10-96BE-EF4AB835BFB4}" type="datetimeFigureOut">
              <a:rPr lang="en-US" smtClean="0"/>
              <a:t>9/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9FA9E6-CD19-4A88-BFCC-81ECC6B42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0849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9FA9E6-CD19-4A88-BFCC-81ECC6B42FF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18395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9FA9E6-CD19-4A88-BFCC-81ECC6B42FF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5370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CBD5AA-47A7-4D5F-A360-AA26BB43CF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4C9A60C-7902-3A67-C9D4-96921F606E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06C369-78DC-21E0-256D-B549ADDD76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E0888-948C-4999-A90E-732B9D8F0238}" type="datetimeFigureOut">
              <a:rPr lang="en-US" smtClean="0"/>
              <a:t>9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28D0FF-F45F-E5BC-2730-95262D6C2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FBC319-EE3D-5FCB-A9D5-F0308E2FC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4F621-50F4-4C98-BA99-A2483E96F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34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81A5C2-15E8-5B88-FAF1-582BE0EA52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A228C7-9A89-12B0-B4E9-72E3AADED2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5103A5-26C7-F385-5761-DC9724B1AE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E0888-948C-4999-A90E-732B9D8F0238}" type="datetimeFigureOut">
              <a:rPr lang="en-US" smtClean="0"/>
              <a:t>9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5F2053-E4A7-C158-72C7-FF429AF8B4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1D1362-9181-B187-9093-2D0C58C28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4F621-50F4-4C98-BA99-A2483E96F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7555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94E0E31-C63D-FDC0-142E-BCB0228226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10B8F2-28D3-1787-6BFF-E056824608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DC0557-EE52-6933-F560-0BF8DD467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E0888-948C-4999-A90E-732B9D8F0238}" type="datetimeFigureOut">
              <a:rPr lang="en-US" smtClean="0"/>
              <a:t>9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2E0362-1C16-AEB5-362B-E30E340D0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7FDC4B-1112-DF63-FDD7-4A394A714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4F621-50F4-4C98-BA99-A2483E96F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092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A2DD8F-EF47-7B89-B785-04664A499B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E1F135-2B95-F5A4-3B80-46F78DF46B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92F76B-3DA2-2E33-C2FE-BE4C1FFA9C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E0888-948C-4999-A90E-732B9D8F0238}" type="datetimeFigureOut">
              <a:rPr lang="en-US" smtClean="0"/>
              <a:t>9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DBD1A0-8D8E-8E7C-16C4-6C680CF0F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EAF271-4C4D-2443-3047-A09FAA0A99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4F621-50F4-4C98-BA99-A2483E96F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5457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B03826-E141-C599-5C80-CCB1AC1DE3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5ACF7F-707D-F2FE-9CF1-E8A5DC00E1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11F3FD-A2A0-52D7-FAA6-4E7B9131D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E0888-948C-4999-A90E-732B9D8F0238}" type="datetimeFigureOut">
              <a:rPr lang="en-US" smtClean="0"/>
              <a:t>9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944B3D-F260-2FD4-B3DB-4759B7BD5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EEA337-BA9D-108E-6EB6-8552B881F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4F621-50F4-4C98-BA99-A2483E96F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222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7CDAD-095D-D7C9-7471-5639ABDCA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9192C5-A619-69D7-961E-48DB5F1296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6225A7-23DC-D612-DCD8-0BCA745845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1EE5AC-7120-10EB-1240-F689265B9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E0888-948C-4999-A90E-732B9D8F0238}" type="datetimeFigureOut">
              <a:rPr lang="en-US" smtClean="0"/>
              <a:t>9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95F741-473D-F8A6-8714-C478A69E2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C03CDF-C23C-C648-5AB5-BC5ADD2733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4F621-50F4-4C98-BA99-A2483E96F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852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4F9693-0CE7-51ED-CF4E-80204831BA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E2A2D1-8B77-1F62-ED5B-14733AAB56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720733-437E-30AE-E461-FB380EA397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88864A4-8B5C-ED01-CFE0-E9FE356D68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79FB68E-A467-C0FE-0C75-19CADBBC0D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BCE46DC-71D8-E737-5ED2-8989DCF44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E0888-948C-4999-A90E-732B9D8F0238}" type="datetimeFigureOut">
              <a:rPr lang="en-US" smtClean="0"/>
              <a:t>9/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2F5744-FC9B-6375-6E60-C6988B9BD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F717066-8522-5AE7-9CD8-CCE7D4700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4F621-50F4-4C98-BA99-A2483E96F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421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05D368-63D5-6393-FB3A-109A79094F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A097419-9200-664D-CEC4-23C2B1FEAC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E0888-948C-4999-A90E-732B9D8F0238}" type="datetimeFigureOut">
              <a:rPr lang="en-US" smtClean="0"/>
              <a:t>9/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D5A4861-3678-EE58-586B-549E21857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512E7BB-2344-FA0D-D835-18D77E9F5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4F621-50F4-4C98-BA99-A2483E96F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854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B54F1A3-5987-EBEE-0CC3-4E1F2822F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E0888-948C-4999-A90E-732B9D8F0238}" type="datetimeFigureOut">
              <a:rPr lang="en-US" smtClean="0"/>
              <a:t>9/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D0CA55F-F5E6-F8C8-DE5B-B8683EB7DA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25180AA-FBF2-0391-E515-6ADDDCE48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4F621-50F4-4C98-BA99-A2483E96F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265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F54067-2A3E-60D3-1D54-BC15E915DC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96BCD8-9D0D-CAA1-65F5-37C1C5D9AE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AAB480-BFB3-FECA-560F-681AD0FC85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CDD91C-304B-A9C7-EB3B-1069898160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E0888-948C-4999-A90E-732B9D8F0238}" type="datetimeFigureOut">
              <a:rPr lang="en-US" smtClean="0"/>
              <a:t>9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347722-ACC3-5B4D-01C4-5FDCF355F4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233715-0E5D-CD2F-A235-3E2F2C027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4F621-50F4-4C98-BA99-A2483E96F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3384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7B5A80-5EBC-9050-F6CB-EADD818B97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E0C5271-B8D0-6C7C-65C4-C6808A42E7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F472E9-D1DC-7D67-6676-7AEE68F3AC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5BA99-AAF3-2CD2-9D82-4F746A3AEB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E0888-948C-4999-A90E-732B9D8F0238}" type="datetimeFigureOut">
              <a:rPr lang="en-US" smtClean="0"/>
              <a:t>9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91964C-5DAE-EDFF-C4A3-FA99E69D8D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7AAC1E-7504-BAC6-247C-D28184236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4F621-50F4-4C98-BA99-A2483E96F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903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F61CBA3-1F28-0CD5-EA08-E0A9DE57EF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A7A425-8BD1-0740-F8E2-333797A215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5D55A9-B45F-F9AA-099D-0F0BC238E1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A1E0888-948C-4999-A90E-732B9D8F0238}" type="datetimeFigureOut">
              <a:rPr lang="en-US" smtClean="0"/>
              <a:t>9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1D8DDE-0577-0102-454C-9C56C535FB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2109B4-6EC8-35DE-C282-6840983373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C64F621-50F4-4C98-BA99-A2483E96F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86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microsoft.com/office/2007/relationships/hdphoto" Target="../media/hdphoto4.wdp"/><Relationship Id="rId5" Type="http://schemas.openxmlformats.org/officeDocument/2006/relationships/image" Target="../media/image4.png"/><Relationship Id="rId4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11BE742-C992-B3B3-E0AB-F168EABC3DB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oup 42">
            <a:extLst>
              <a:ext uri="{FF2B5EF4-FFF2-40B4-BE49-F238E27FC236}">
                <a16:creationId xmlns:a16="http://schemas.microsoft.com/office/drawing/2014/main" id="{83FBC73B-B310-538E-D614-B01D607B3F79}"/>
              </a:ext>
            </a:extLst>
          </p:cNvPr>
          <p:cNvGrpSpPr/>
          <p:nvPr/>
        </p:nvGrpSpPr>
        <p:grpSpPr>
          <a:xfrm>
            <a:off x="6295664" y="1642229"/>
            <a:ext cx="5267650" cy="4359041"/>
            <a:chOff x="554082" y="1667960"/>
            <a:chExt cx="5267650" cy="4359041"/>
          </a:xfrm>
        </p:grpSpPr>
        <p:pic>
          <p:nvPicPr>
            <p:cNvPr id="1026" name="Picture 2">
              <a:extLst>
                <a:ext uri="{FF2B5EF4-FFF2-40B4-BE49-F238E27FC236}">
                  <a16:creationId xmlns:a16="http://schemas.microsoft.com/office/drawing/2014/main" id="{C4583C09-D79F-B576-B821-DAC7C1C839F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1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1445077" y="1957647"/>
              <a:ext cx="4376655" cy="40693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09FC9934-7150-35B8-3B93-1EA55FB8AA19}"/>
                </a:ext>
              </a:extLst>
            </p:cNvPr>
            <p:cNvGrpSpPr/>
            <p:nvPr/>
          </p:nvGrpSpPr>
          <p:grpSpPr>
            <a:xfrm>
              <a:off x="554082" y="1667960"/>
              <a:ext cx="933137" cy="3575131"/>
              <a:chOff x="554082" y="1667960"/>
              <a:chExt cx="933137" cy="3575131"/>
            </a:xfrm>
          </p:grpSpPr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34AF2756-4A0F-02C7-0385-C81E04DACC03}"/>
                  </a:ext>
                </a:extLst>
              </p:cNvPr>
              <p:cNvSpPr txBox="1"/>
              <p:nvPr/>
            </p:nvSpPr>
            <p:spPr>
              <a:xfrm>
                <a:off x="570814" y="1667960"/>
                <a:ext cx="916405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Ladder</a:t>
                </a:r>
              </a:p>
              <a:p>
                <a:r>
                  <a:rPr lang="en-US" b="1" dirty="0"/>
                  <a:t>(</a:t>
                </a:r>
                <a:r>
                  <a:rPr lang="en-US" b="1" dirty="0" err="1"/>
                  <a:t>kDa</a:t>
                </a:r>
                <a:r>
                  <a:rPr lang="en-US" b="1" dirty="0"/>
                  <a:t>)</a:t>
                </a:r>
              </a:p>
            </p:txBody>
          </p: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D8263F78-13F2-3248-6C5C-B7AD79AD233C}"/>
                  </a:ext>
                </a:extLst>
              </p:cNvPr>
              <p:cNvGrpSpPr/>
              <p:nvPr/>
            </p:nvGrpSpPr>
            <p:grpSpPr>
              <a:xfrm>
                <a:off x="554082" y="2246660"/>
                <a:ext cx="875290" cy="2996431"/>
                <a:chOff x="554082" y="2246660"/>
                <a:chExt cx="875290" cy="2996431"/>
              </a:xfrm>
            </p:grpSpPr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id="{290C7399-C8B2-9F3C-6765-B03A41DF2533}"/>
                    </a:ext>
                  </a:extLst>
                </p:cNvPr>
                <p:cNvSpPr txBox="1"/>
                <p:nvPr/>
              </p:nvSpPr>
              <p:spPr>
                <a:xfrm>
                  <a:off x="554082" y="2246660"/>
                  <a:ext cx="55496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250</a:t>
                  </a:r>
                </a:p>
              </p:txBody>
            </p:sp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215C03CB-86FF-C783-0835-EBB261AE3FAC}"/>
                    </a:ext>
                  </a:extLst>
                </p:cNvPr>
                <p:cNvSpPr txBox="1"/>
                <p:nvPr/>
              </p:nvSpPr>
              <p:spPr>
                <a:xfrm>
                  <a:off x="554082" y="2689052"/>
                  <a:ext cx="55651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100</a:t>
                  </a:r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60EBF50E-05CD-A3A7-1B2D-A8E1374DB2C8}"/>
                    </a:ext>
                  </a:extLst>
                </p:cNvPr>
                <p:cNvSpPr txBox="1"/>
                <p:nvPr/>
              </p:nvSpPr>
              <p:spPr>
                <a:xfrm>
                  <a:off x="554082" y="2462989"/>
                  <a:ext cx="55496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130</a:t>
                  </a: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83BFF785-0866-85D4-8F92-E8AC23E055AF}"/>
                    </a:ext>
                  </a:extLst>
                </p:cNvPr>
                <p:cNvSpPr txBox="1"/>
                <p:nvPr/>
              </p:nvSpPr>
              <p:spPr>
                <a:xfrm>
                  <a:off x="707463" y="2889811"/>
                  <a:ext cx="55496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70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D54EA305-255C-DB31-6F76-465E69F87213}"/>
                    </a:ext>
                  </a:extLst>
                </p:cNvPr>
                <p:cNvSpPr txBox="1"/>
                <p:nvPr/>
              </p:nvSpPr>
              <p:spPr>
                <a:xfrm>
                  <a:off x="677514" y="3785407"/>
                  <a:ext cx="4315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35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06C4E4A1-F707-5ABD-EFB2-044704B05B38}"/>
                    </a:ext>
                  </a:extLst>
                </p:cNvPr>
                <p:cNvSpPr txBox="1"/>
                <p:nvPr/>
              </p:nvSpPr>
              <p:spPr>
                <a:xfrm>
                  <a:off x="677514" y="3218371"/>
                  <a:ext cx="4315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55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D9F4A000-3EEB-135C-5FBD-DFC6F1026338}"/>
                    </a:ext>
                  </a:extLst>
                </p:cNvPr>
                <p:cNvSpPr txBox="1"/>
                <p:nvPr/>
              </p:nvSpPr>
              <p:spPr>
                <a:xfrm>
                  <a:off x="677514" y="4873759"/>
                  <a:ext cx="4315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25</a:t>
                  </a:r>
                </a:p>
              </p:txBody>
            </p:sp>
            <p:cxnSp>
              <p:nvCxnSpPr>
                <p:cNvPr id="13" name="Straight Arrow Connector 12">
                  <a:extLst>
                    <a:ext uri="{FF2B5EF4-FFF2-40B4-BE49-F238E27FC236}">
                      <a16:creationId xmlns:a16="http://schemas.microsoft.com/office/drawing/2014/main" id="{A5C83B97-3A2A-4BC7-E71C-18074C802CF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2455957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Arrow Connector 13">
                  <a:extLst>
                    <a:ext uri="{FF2B5EF4-FFF2-40B4-BE49-F238E27FC236}">
                      <a16:creationId xmlns:a16="http://schemas.microsoft.com/office/drawing/2014/main" id="{ADA9FC60-DBBE-227F-EDBA-C7939AD45B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2640623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Arrow Connector 14">
                  <a:extLst>
                    <a:ext uri="{FF2B5EF4-FFF2-40B4-BE49-F238E27FC236}">
                      <a16:creationId xmlns:a16="http://schemas.microsoft.com/office/drawing/2014/main" id="{59614130-5173-5323-3059-0657ECD7CB8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2879050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Arrow Connector 15">
                  <a:extLst>
                    <a:ext uri="{FF2B5EF4-FFF2-40B4-BE49-F238E27FC236}">
                      <a16:creationId xmlns:a16="http://schemas.microsoft.com/office/drawing/2014/main" id="{7640E517-ED67-36C5-E217-D0F3C5FBA2D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3070748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Arrow Connector 16">
                  <a:extLst>
                    <a:ext uri="{FF2B5EF4-FFF2-40B4-BE49-F238E27FC236}">
                      <a16:creationId xmlns:a16="http://schemas.microsoft.com/office/drawing/2014/main" id="{FD199D1E-BA89-E883-7D3F-8BF286D13C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3974627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Arrow Connector 17">
                  <a:extLst>
                    <a:ext uri="{FF2B5EF4-FFF2-40B4-BE49-F238E27FC236}">
                      <a16:creationId xmlns:a16="http://schemas.microsoft.com/office/drawing/2014/main" id="{305D0ACA-8993-A59A-634C-BB297FC048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3365999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Arrow Connector 18">
                  <a:extLst>
                    <a:ext uri="{FF2B5EF4-FFF2-40B4-BE49-F238E27FC236}">
                      <a16:creationId xmlns:a16="http://schemas.microsoft.com/office/drawing/2014/main" id="{C0A4A51F-4A51-12CC-82BA-00F1A24877D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5058425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60CCC7F7-559B-E761-1197-C01BD20CD12E}"/>
              </a:ext>
            </a:extLst>
          </p:cNvPr>
          <p:cNvGrpSpPr/>
          <p:nvPr/>
        </p:nvGrpSpPr>
        <p:grpSpPr>
          <a:xfrm>
            <a:off x="302536" y="1537824"/>
            <a:ext cx="5294160" cy="4463446"/>
            <a:chOff x="5884629" y="1714172"/>
            <a:chExt cx="5294160" cy="4463446"/>
          </a:xfrm>
        </p:grpSpPr>
        <p:pic>
          <p:nvPicPr>
            <p:cNvPr id="1027" name="Picture 1">
              <a:extLst>
                <a:ext uri="{FF2B5EF4-FFF2-40B4-BE49-F238E27FC236}">
                  <a16:creationId xmlns:a16="http://schemas.microsoft.com/office/drawing/2014/main" id="{34664D74-2296-5856-8790-F0576B5DD00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22917" y="2108264"/>
              <a:ext cx="4355872" cy="40693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3337E2FD-AAA9-5F3C-373D-30CDD1B51BD1}"/>
                </a:ext>
              </a:extLst>
            </p:cNvPr>
            <p:cNvGrpSpPr/>
            <p:nvPr/>
          </p:nvGrpSpPr>
          <p:grpSpPr>
            <a:xfrm>
              <a:off x="5884629" y="1714172"/>
              <a:ext cx="933137" cy="3620851"/>
              <a:chOff x="554082" y="1667960"/>
              <a:chExt cx="933137" cy="3620851"/>
            </a:xfrm>
          </p:grpSpPr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625CE7FF-7891-9BEC-7413-3A3010F9131E}"/>
                  </a:ext>
                </a:extLst>
              </p:cNvPr>
              <p:cNvSpPr txBox="1"/>
              <p:nvPr/>
            </p:nvSpPr>
            <p:spPr>
              <a:xfrm>
                <a:off x="570814" y="1667960"/>
                <a:ext cx="916405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Ladder</a:t>
                </a:r>
              </a:p>
              <a:p>
                <a:r>
                  <a:rPr lang="en-US" b="1" dirty="0"/>
                  <a:t>(</a:t>
                </a:r>
                <a:r>
                  <a:rPr lang="en-US" b="1" dirty="0" err="1"/>
                  <a:t>kDa</a:t>
                </a:r>
                <a:r>
                  <a:rPr lang="en-US" b="1" dirty="0"/>
                  <a:t>)</a:t>
                </a:r>
              </a:p>
            </p:txBody>
          </p:sp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D2E3B5CC-FE88-F1A8-BDE6-4A80934C79D4}"/>
                  </a:ext>
                </a:extLst>
              </p:cNvPr>
              <p:cNvGrpSpPr/>
              <p:nvPr/>
            </p:nvGrpSpPr>
            <p:grpSpPr>
              <a:xfrm>
                <a:off x="554082" y="2246660"/>
                <a:ext cx="875290" cy="3042151"/>
                <a:chOff x="554082" y="2246660"/>
                <a:chExt cx="875290" cy="3042151"/>
              </a:xfrm>
            </p:grpSpPr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96F26B3D-535A-FCCA-F65C-EC8C5EA0D3BF}"/>
                    </a:ext>
                  </a:extLst>
                </p:cNvPr>
                <p:cNvSpPr txBox="1"/>
                <p:nvPr/>
              </p:nvSpPr>
              <p:spPr>
                <a:xfrm>
                  <a:off x="554082" y="2246660"/>
                  <a:ext cx="55496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250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30E3448E-4CE5-CEFB-31A1-7DC4FB2F5332}"/>
                    </a:ext>
                  </a:extLst>
                </p:cNvPr>
                <p:cNvSpPr txBox="1"/>
                <p:nvPr/>
              </p:nvSpPr>
              <p:spPr>
                <a:xfrm>
                  <a:off x="554082" y="2689052"/>
                  <a:ext cx="55651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100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2ADA5F21-46E2-2D15-74A9-E9EFC9DA4201}"/>
                    </a:ext>
                  </a:extLst>
                </p:cNvPr>
                <p:cNvSpPr txBox="1"/>
                <p:nvPr/>
              </p:nvSpPr>
              <p:spPr>
                <a:xfrm>
                  <a:off x="554082" y="2462989"/>
                  <a:ext cx="55496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130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E18214C9-16C6-0C60-626F-86F12CAAA6B2}"/>
                    </a:ext>
                  </a:extLst>
                </p:cNvPr>
                <p:cNvSpPr txBox="1"/>
                <p:nvPr/>
              </p:nvSpPr>
              <p:spPr>
                <a:xfrm>
                  <a:off x="677514" y="2867007"/>
                  <a:ext cx="55496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70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D83469F9-2F46-2A1E-2EB8-B305F3641E6E}"/>
                    </a:ext>
                  </a:extLst>
                </p:cNvPr>
                <p:cNvSpPr txBox="1"/>
                <p:nvPr/>
              </p:nvSpPr>
              <p:spPr>
                <a:xfrm>
                  <a:off x="677514" y="3785407"/>
                  <a:ext cx="4315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35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44235CC2-4514-E82A-00F0-044077A39FFC}"/>
                    </a:ext>
                  </a:extLst>
                </p:cNvPr>
                <p:cNvSpPr txBox="1"/>
                <p:nvPr/>
              </p:nvSpPr>
              <p:spPr>
                <a:xfrm>
                  <a:off x="691935" y="3175153"/>
                  <a:ext cx="4315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55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4BC37E2B-0664-24E9-C9B4-C056E16567A8}"/>
                    </a:ext>
                  </a:extLst>
                </p:cNvPr>
                <p:cNvSpPr txBox="1"/>
                <p:nvPr/>
              </p:nvSpPr>
              <p:spPr>
                <a:xfrm>
                  <a:off x="677514" y="4919479"/>
                  <a:ext cx="4315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25</a:t>
                  </a:r>
                </a:p>
              </p:txBody>
            </p:sp>
            <p:cxnSp>
              <p:nvCxnSpPr>
                <p:cNvPr id="34" name="Straight Arrow Connector 33">
                  <a:extLst>
                    <a:ext uri="{FF2B5EF4-FFF2-40B4-BE49-F238E27FC236}">
                      <a16:creationId xmlns:a16="http://schemas.microsoft.com/office/drawing/2014/main" id="{ADE0DD47-0E87-3F71-26F8-BB9C65941E3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2467755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Straight Arrow Connector 34">
                  <a:extLst>
                    <a:ext uri="{FF2B5EF4-FFF2-40B4-BE49-F238E27FC236}">
                      <a16:creationId xmlns:a16="http://schemas.microsoft.com/office/drawing/2014/main" id="{71AD09B6-3625-3D79-80F6-BB442DEDEC3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2640623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Arrow Connector 35">
                  <a:extLst>
                    <a:ext uri="{FF2B5EF4-FFF2-40B4-BE49-F238E27FC236}">
                      <a16:creationId xmlns:a16="http://schemas.microsoft.com/office/drawing/2014/main" id="{6B345F00-E61D-C845-A5E6-EFB7D4908E9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2879050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Straight Arrow Connector 36">
                  <a:extLst>
                    <a:ext uri="{FF2B5EF4-FFF2-40B4-BE49-F238E27FC236}">
                      <a16:creationId xmlns:a16="http://schemas.microsoft.com/office/drawing/2014/main" id="{CDC5EC35-EB4D-FFE9-BB2E-0589D4209A4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3070748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Arrow Connector 37">
                  <a:extLst>
                    <a:ext uri="{FF2B5EF4-FFF2-40B4-BE49-F238E27FC236}">
                      <a16:creationId xmlns:a16="http://schemas.microsoft.com/office/drawing/2014/main" id="{3132BFE4-98DF-B24E-D243-926FD65DC9E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3974627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Straight Arrow Connector 38">
                  <a:extLst>
                    <a:ext uri="{FF2B5EF4-FFF2-40B4-BE49-F238E27FC236}">
                      <a16:creationId xmlns:a16="http://schemas.microsoft.com/office/drawing/2014/main" id="{72955E43-017C-6FC5-16A8-51AED202DE0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3365999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Straight Arrow Connector 39">
                  <a:extLst>
                    <a:ext uri="{FF2B5EF4-FFF2-40B4-BE49-F238E27FC236}">
                      <a16:creationId xmlns:a16="http://schemas.microsoft.com/office/drawing/2014/main" id="{2DA9BBFA-1506-7D32-1909-42D8F72117A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5104145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B7C5B718-103B-A926-B55F-68257586752B}"/>
              </a:ext>
            </a:extLst>
          </p:cNvPr>
          <p:cNvSpPr txBox="1"/>
          <p:nvPr/>
        </p:nvSpPr>
        <p:spPr>
          <a:xfrm>
            <a:off x="570814" y="542260"/>
            <a:ext cx="9498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umor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2E2A621-6DCF-F4EA-48E8-C5DDFCDE8841}"/>
              </a:ext>
            </a:extLst>
          </p:cNvPr>
          <p:cNvSpPr txBox="1"/>
          <p:nvPr/>
        </p:nvSpPr>
        <p:spPr>
          <a:xfrm>
            <a:off x="1662289" y="2806590"/>
            <a:ext cx="37921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ehicle      SHP2i   </a:t>
            </a:r>
            <a:r>
              <a:rPr lang="en-US" dirty="0" err="1"/>
              <a:t>SHP2i</a:t>
            </a:r>
            <a:r>
              <a:rPr lang="en-US" dirty="0"/>
              <a:t>         not</a:t>
            </a:r>
          </a:p>
          <a:p>
            <a:r>
              <a:rPr lang="en-US" dirty="0"/>
              <a:t>                                      +MEKi         relevant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E3B3B896-54A3-EC59-DE45-CB3C3FFB27F3}"/>
              </a:ext>
            </a:extLst>
          </p:cNvPr>
          <p:cNvSpPr/>
          <p:nvPr/>
        </p:nvSpPr>
        <p:spPr>
          <a:xfrm>
            <a:off x="1520626" y="3192640"/>
            <a:ext cx="1169411" cy="756256"/>
          </a:xfrm>
          <a:prstGeom prst="rect">
            <a:avLst/>
          </a:prstGeom>
          <a:noFill/>
          <a:ln>
            <a:solidFill>
              <a:schemeClr val="accent1">
                <a:shade val="15000"/>
                <a:alpha val="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8EA59F1C-8BB1-BC1B-C57A-FD614489398B}"/>
              </a:ext>
            </a:extLst>
          </p:cNvPr>
          <p:cNvCxnSpPr>
            <a:cxnSpLocks/>
          </p:cNvCxnSpPr>
          <p:nvPr/>
        </p:nvCxnSpPr>
        <p:spPr>
          <a:xfrm rot="5400000">
            <a:off x="2264736" y="3561972"/>
            <a:ext cx="776176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F4B3B617-CD82-CDDB-B897-60B84936A2FA}"/>
              </a:ext>
            </a:extLst>
          </p:cNvPr>
          <p:cNvCxnSpPr>
            <a:cxnSpLocks/>
          </p:cNvCxnSpPr>
          <p:nvPr/>
        </p:nvCxnSpPr>
        <p:spPr>
          <a:xfrm rot="5400000">
            <a:off x="3030672" y="3561972"/>
            <a:ext cx="776176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FDB5D3D8-1EC8-CBA9-34F3-AEE53A1BB3D6}"/>
              </a:ext>
            </a:extLst>
          </p:cNvPr>
          <p:cNvCxnSpPr>
            <a:cxnSpLocks/>
          </p:cNvCxnSpPr>
          <p:nvPr/>
        </p:nvCxnSpPr>
        <p:spPr>
          <a:xfrm rot="5400000">
            <a:off x="4056322" y="3561972"/>
            <a:ext cx="776176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66CBF998-3A86-7A04-FBD7-C3B2ED0E14C8}"/>
              </a:ext>
            </a:extLst>
          </p:cNvPr>
          <p:cNvSpPr txBox="1"/>
          <p:nvPr/>
        </p:nvSpPr>
        <p:spPr>
          <a:xfrm>
            <a:off x="7569439" y="2891136"/>
            <a:ext cx="37921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ehicle      SHP2i   </a:t>
            </a:r>
            <a:r>
              <a:rPr lang="en-US" dirty="0" err="1"/>
              <a:t>SHP2i</a:t>
            </a:r>
            <a:r>
              <a:rPr lang="en-US" dirty="0"/>
              <a:t>         not</a:t>
            </a:r>
          </a:p>
          <a:p>
            <a:r>
              <a:rPr lang="en-US" dirty="0"/>
              <a:t>                                      +MEKi         relevant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BC1F99DC-B0AF-562B-89A5-020FA7F73ACA}"/>
              </a:ext>
            </a:extLst>
          </p:cNvPr>
          <p:cNvCxnSpPr>
            <a:cxnSpLocks/>
          </p:cNvCxnSpPr>
          <p:nvPr/>
        </p:nvCxnSpPr>
        <p:spPr>
          <a:xfrm rot="5400000">
            <a:off x="8171886" y="3646518"/>
            <a:ext cx="776176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39F682AE-8E28-7CD7-829E-35D5C768B09A}"/>
              </a:ext>
            </a:extLst>
          </p:cNvPr>
          <p:cNvCxnSpPr>
            <a:cxnSpLocks/>
          </p:cNvCxnSpPr>
          <p:nvPr/>
        </p:nvCxnSpPr>
        <p:spPr>
          <a:xfrm rot="5400000">
            <a:off x="8937822" y="3646518"/>
            <a:ext cx="776176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7E22C467-224C-9230-B155-5BA8F80B5B30}"/>
              </a:ext>
            </a:extLst>
          </p:cNvPr>
          <p:cNvCxnSpPr>
            <a:cxnSpLocks/>
          </p:cNvCxnSpPr>
          <p:nvPr/>
        </p:nvCxnSpPr>
        <p:spPr>
          <a:xfrm rot="5400000">
            <a:off x="9963472" y="3646518"/>
            <a:ext cx="776176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CDE89CFB-3217-086A-6DF3-475D42755BE0}"/>
              </a:ext>
            </a:extLst>
          </p:cNvPr>
          <p:cNvSpPr txBox="1"/>
          <p:nvPr/>
        </p:nvSpPr>
        <p:spPr>
          <a:xfrm>
            <a:off x="8864746" y="1780728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/>
              <a:t>tERK</a:t>
            </a:r>
            <a:endParaRPr lang="en-US" b="1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E59A818-0A37-CAD0-563F-B60FC90D745D}"/>
              </a:ext>
            </a:extLst>
          </p:cNvPr>
          <p:cNvSpPr txBox="1"/>
          <p:nvPr/>
        </p:nvSpPr>
        <p:spPr>
          <a:xfrm>
            <a:off x="3191429" y="1794629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/>
              <a:t>pERK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1843672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49" name="Group 2048">
            <a:extLst>
              <a:ext uri="{FF2B5EF4-FFF2-40B4-BE49-F238E27FC236}">
                <a16:creationId xmlns:a16="http://schemas.microsoft.com/office/drawing/2014/main" id="{EC97BBE2-D6DD-482E-2532-ECAEB0A18511}"/>
              </a:ext>
            </a:extLst>
          </p:cNvPr>
          <p:cNvGrpSpPr/>
          <p:nvPr/>
        </p:nvGrpSpPr>
        <p:grpSpPr>
          <a:xfrm>
            <a:off x="6059667" y="1485752"/>
            <a:ext cx="5282012" cy="4503566"/>
            <a:chOff x="6059667" y="1485752"/>
            <a:chExt cx="5282012" cy="4503566"/>
          </a:xfrm>
        </p:grpSpPr>
        <p:pic>
          <p:nvPicPr>
            <p:cNvPr id="2050" name="Picture 4">
              <a:extLst>
                <a:ext uri="{FF2B5EF4-FFF2-40B4-BE49-F238E27FC236}">
                  <a16:creationId xmlns:a16="http://schemas.microsoft.com/office/drawing/2014/main" id="{906A15FD-7A02-2860-F68F-4761C7BE8859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1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6989135" y="1702235"/>
              <a:ext cx="4352544" cy="42870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413840F-DFDD-28EF-AF38-99B4EFAD7E83}"/>
                </a:ext>
              </a:extLst>
            </p:cNvPr>
            <p:cNvGrpSpPr/>
            <p:nvPr/>
          </p:nvGrpSpPr>
          <p:grpSpPr>
            <a:xfrm>
              <a:off x="6059667" y="1485752"/>
              <a:ext cx="933137" cy="3471992"/>
              <a:chOff x="554082" y="1667960"/>
              <a:chExt cx="933137" cy="3471992"/>
            </a:xfrm>
          </p:grpSpPr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7C2079BE-0DA6-B7DA-BBDA-8CCF007735A2}"/>
                  </a:ext>
                </a:extLst>
              </p:cNvPr>
              <p:cNvSpPr txBox="1"/>
              <p:nvPr/>
            </p:nvSpPr>
            <p:spPr>
              <a:xfrm>
                <a:off x="570814" y="1667960"/>
                <a:ext cx="916405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Ladder</a:t>
                </a:r>
              </a:p>
              <a:p>
                <a:r>
                  <a:rPr lang="en-US" b="1" dirty="0"/>
                  <a:t>(</a:t>
                </a:r>
                <a:r>
                  <a:rPr lang="en-US" b="1" dirty="0" err="1"/>
                  <a:t>kDa</a:t>
                </a:r>
                <a:r>
                  <a:rPr lang="en-US" b="1" dirty="0"/>
                  <a:t>)</a:t>
                </a:r>
              </a:p>
            </p:txBody>
          </p:sp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A705F1F7-67E7-6745-148F-12DE9CD95322}"/>
                  </a:ext>
                </a:extLst>
              </p:cNvPr>
              <p:cNvGrpSpPr/>
              <p:nvPr/>
            </p:nvGrpSpPr>
            <p:grpSpPr>
              <a:xfrm>
                <a:off x="554082" y="2246660"/>
                <a:ext cx="875290" cy="2893292"/>
                <a:chOff x="554082" y="2246660"/>
                <a:chExt cx="875290" cy="2893292"/>
              </a:xfrm>
            </p:grpSpPr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D4895268-3BA9-6C7A-15E9-7E0B6A3A65FF}"/>
                    </a:ext>
                  </a:extLst>
                </p:cNvPr>
                <p:cNvSpPr txBox="1"/>
                <p:nvPr/>
              </p:nvSpPr>
              <p:spPr>
                <a:xfrm>
                  <a:off x="554082" y="2246660"/>
                  <a:ext cx="55496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250</a:t>
                  </a: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67A5DBCF-291E-9420-6329-FD9206146A6A}"/>
                    </a:ext>
                  </a:extLst>
                </p:cNvPr>
                <p:cNvSpPr txBox="1"/>
                <p:nvPr/>
              </p:nvSpPr>
              <p:spPr>
                <a:xfrm>
                  <a:off x="554082" y="2997401"/>
                  <a:ext cx="55651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100</a:t>
                  </a: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DFEB5C84-061F-A63C-0D2B-C84A9F2E79AA}"/>
                    </a:ext>
                  </a:extLst>
                </p:cNvPr>
                <p:cNvSpPr txBox="1"/>
                <p:nvPr/>
              </p:nvSpPr>
              <p:spPr>
                <a:xfrm>
                  <a:off x="554082" y="2707543"/>
                  <a:ext cx="55496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130</a:t>
                  </a: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CD09E47A-8A7B-0E0C-7ECB-DAC006DA2444}"/>
                    </a:ext>
                  </a:extLst>
                </p:cNvPr>
                <p:cNvSpPr txBox="1"/>
                <p:nvPr/>
              </p:nvSpPr>
              <p:spPr>
                <a:xfrm>
                  <a:off x="707463" y="3261955"/>
                  <a:ext cx="55496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70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A1E2AE7E-FCCB-921D-7108-1E3AF7A64C61}"/>
                    </a:ext>
                  </a:extLst>
                </p:cNvPr>
                <p:cNvSpPr txBox="1"/>
                <p:nvPr/>
              </p:nvSpPr>
              <p:spPr>
                <a:xfrm>
                  <a:off x="677514" y="3969140"/>
                  <a:ext cx="4315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35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65DDE612-50C4-3602-8D4B-BCEDEDFC8E5E}"/>
                    </a:ext>
                  </a:extLst>
                </p:cNvPr>
                <p:cNvSpPr txBox="1"/>
                <p:nvPr/>
              </p:nvSpPr>
              <p:spPr>
                <a:xfrm>
                  <a:off x="677514" y="3573929"/>
                  <a:ext cx="4315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55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AB551CFE-CE46-E0C0-7C8E-4524972B1E15}"/>
                    </a:ext>
                  </a:extLst>
                </p:cNvPr>
                <p:cNvSpPr txBox="1"/>
                <p:nvPr/>
              </p:nvSpPr>
              <p:spPr>
                <a:xfrm>
                  <a:off x="664846" y="4770620"/>
                  <a:ext cx="4315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25</a:t>
                  </a:r>
                </a:p>
              </p:txBody>
            </p:sp>
            <p:cxnSp>
              <p:nvCxnSpPr>
                <p:cNvPr id="12" name="Straight Arrow Connector 11">
                  <a:extLst>
                    <a:ext uri="{FF2B5EF4-FFF2-40B4-BE49-F238E27FC236}">
                      <a16:creationId xmlns:a16="http://schemas.microsoft.com/office/drawing/2014/main" id="{42AA7B23-1E5E-6AD8-A94D-0E706605C50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2455957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Arrow Connector 12">
                  <a:extLst>
                    <a:ext uri="{FF2B5EF4-FFF2-40B4-BE49-F238E27FC236}">
                      <a16:creationId xmlns:a16="http://schemas.microsoft.com/office/drawing/2014/main" id="{258126A7-B697-E626-54B9-AED8E3A1CED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2885177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Arrow Connector 13">
                  <a:extLst>
                    <a:ext uri="{FF2B5EF4-FFF2-40B4-BE49-F238E27FC236}">
                      <a16:creationId xmlns:a16="http://schemas.microsoft.com/office/drawing/2014/main" id="{D8867075-81A0-44B6-C5E9-B081ADC6D71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3187399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Arrow Connector 14">
                  <a:extLst>
                    <a:ext uri="{FF2B5EF4-FFF2-40B4-BE49-F238E27FC236}">
                      <a16:creationId xmlns:a16="http://schemas.microsoft.com/office/drawing/2014/main" id="{296B0C5E-3C4A-EE48-41BE-C5223CA17E1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3442892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Arrow Connector 15">
                  <a:extLst>
                    <a:ext uri="{FF2B5EF4-FFF2-40B4-BE49-F238E27FC236}">
                      <a16:creationId xmlns:a16="http://schemas.microsoft.com/office/drawing/2014/main" id="{4857F27A-821E-A4D9-9CE7-9E5E3D6C23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4158360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Arrow Connector 16">
                  <a:extLst>
                    <a:ext uri="{FF2B5EF4-FFF2-40B4-BE49-F238E27FC236}">
                      <a16:creationId xmlns:a16="http://schemas.microsoft.com/office/drawing/2014/main" id="{2F40B7E9-0079-7E17-1983-8B14F733934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3721557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Arrow Connector 17">
                  <a:extLst>
                    <a:ext uri="{FF2B5EF4-FFF2-40B4-BE49-F238E27FC236}">
                      <a16:creationId xmlns:a16="http://schemas.microsoft.com/office/drawing/2014/main" id="{8288C424-51CB-97B2-330A-18DB0354BD8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4955286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052" name="Group 2051">
            <a:extLst>
              <a:ext uri="{FF2B5EF4-FFF2-40B4-BE49-F238E27FC236}">
                <a16:creationId xmlns:a16="http://schemas.microsoft.com/office/drawing/2014/main" id="{31690B13-CF78-B052-D6B7-9D82C532656A}"/>
              </a:ext>
            </a:extLst>
          </p:cNvPr>
          <p:cNvGrpSpPr/>
          <p:nvPr/>
        </p:nvGrpSpPr>
        <p:grpSpPr>
          <a:xfrm>
            <a:off x="597857" y="1523453"/>
            <a:ext cx="5257419" cy="4396719"/>
            <a:chOff x="597857" y="1523453"/>
            <a:chExt cx="5257419" cy="4396719"/>
          </a:xfrm>
        </p:grpSpPr>
        <p:pic>
          <p:nvPicPr>
            <p:cNvPr id="2051" name="Picture 2">
              <a:extLst>
                <a:ext uri="{FF2B5EF4-FFF2-40B4-BE49-F238E27FC236}">
                  <a16:creationId xmlns:a16="http://schemas.microsoft.com/office/drawing/2014/main" id="{B23FDC43-8763-49A4-D52E-8776A7D3AD63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17000" contrast="4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300"/>
            <a:stretch>
              <a:fillRect/>
            </a:stretch>
          </p:blipFill>
          <p:spPr bwMode="auto">
            <a:xfrm flipH="1">
              <a:off x="1502732" y="1851092"/>
              <a:ext cx="4352544" cy="40690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1E95CB25-EF2E-4A1C-513A-3C5430A292C0}"/>
                </a:ext>
              </a:extLst>
            </p:cNvPr>
            <p:cNvGrpSpPr/>
            <p:nvPr/>
          </p:nvGrpSpPr>
          <p:grpSpPr>
            <a:xfrm>
              <a:off x="597857" y="1523453"/>
              <a:ext cx="933137" cy="3471992"/>
              <a:chOff x="554082" y="1667960"/>
              <a:chExt cx="933137" cy="3471992"/>
            </a:xfrm>
          </p:grpSpPr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7C3AD745-A70F-2502-4BCB-1A53E0067528}"/>
                  </a:ext>
                </a:extLst>
              </p:cNvPr>
              <p:cNvSpPr txBox="1"/>
              <p:nvPr/>
            </p:nvSpPr>
            <p:spPr>
              <a:xfrm>
                <a:off x="570814" y="1667960"/>
                <a:ext cx="916405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Ladder</a:t>
                </a:r>
              </a:p>
              <a:p>
                <a:r>
                  <a:rPr lang="en-US" b="1" dirty="0"/>
                  <a:t>(</a:t>
                </a:r>
                <a:r>
                  <a:rPr lang="en-US" b="1" dirty="0" err="1"/>
                  <a:t>kDa</a:t>
                </a:r>
                <a:r>
                  <a:rPr lang="en-US" b="1" dirty="0"/>
                  <a:t>)</a:t>
                </a:r>
              </a:p>
            </p:txBody>
          </p:sp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BFF81A91-9330-B080-09A2-F4C0905783DD}"/>
                  </a:ext>
                </a:extLst>
              </p:cNvPr>
              <p:cNvGrpSpPr/>
              <p:nvPr/>
            </p:nvGrpSpPr>
            <p:grpSpPr>
              <a:xfrm>
                <a:off x="554082" y="2246660"/>
                <a:ext cx="875290" cy="2893292"/>
                <a:chOff x="554082" y="2246660"/>
                <a:chExt cx="875290" cy="2893292"/>
              </a:xfrm>
            </p:grpSpPr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2CAF8797-0B91-EB2B-FFA4-4D2DF0EE601E}"/>
                    </a:ext>
                  </a:extLst>
                </p:cNvPr>
                <p:cNvSpPr txBox="1"/>
                <p:nvPr/>
              </p:nvSpPr>
              <p:spPr>
                <a:xfrm>
                  <a:off x="554082" y="2246660"/>
                  <a:ext cx="55496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250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356793ED-9445-8F05-3A06-EDC9BC4FAA08}"/>
                    </a:ext>
                  </a:extLst>
                </p:cNvPr>
                <p:cNvSpPr txBox="1"/>
                <p:nvPr/>
              </p:nvSpPr>
              <p:spPr>
                <a:xfrm>
                  <a:off x="554082" y="2997401"/>
                  <a:ext cx="55651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100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179992A4-B3BE-8CDB-F778-344A99EBE55A}"/>
                    </a:ext>
                  </a:extLst>
                </p:cNvPr>
                <p:cNvSpPr txBox="1"/>
                <p:nvPr/>
              </p:nvSpPr>
              <p:spPr>
                <a:xfrm>
                  <a:off x="554082" y="2707543"/>
                  <a:ext cx="55496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130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DDBB368F-5B3E-F5BC-3A54-2B80A4FBEEE6}"/>
                    </a:ext>
                  </a:extLst>
                </p:cNvPr>
                <p:cNvSpPr txBox="1"/>
                <p:nvPr/>
              </p:nvSpPr>
              <p:spPr>
                <a:xfrm>
                  <a:off x="707463" y="3261955"/>
                  <a:ext cx="55496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70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855E0EF3-4F61-E101-CB4F-B38CAB0631BA}"/>
                    </a:ext>
                  </a:extLst>
                </p:cNvPr>
                <p:cNvSpPr txBox="1"/>
                <p:nvPr/>
              </p:nvSpPr>
              <p:spPr>
                <a:xfrm>
                  <a:off x="677514" y="3987428"/>
                  <a:ext cx="4315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35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E3FB12C8-9CB8-8D3E-59EC-0613F4CB8C6F}"/>
                    </a:ext>
                  </a:extLst>
                </p:cNvPr>
                <p:cNvSpPr txBox="1"/>
                <p:nvPr/>
              </p:nvSpPr>
              <p:spPr>
                <a:xfrm>
                  <a:off x="677514" y="3537353"/>
                  <a:ext cx="4315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55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AC1925D1-825E-ABAF-C6CE-FCCB0361B0CB}"/>
                    </a:ext>
                  </a:extLst>
                </p:cNvPr>
                <p:cNvSpPr txBox="1"/>
                <p:nvPr/>
              </p:nvSpPr>
              <p:spPr>
                <a:xfrm>
                  <a:off x="677514" y="4770620"/>
                  <a:ext cx="4315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25</a:t>
                  </a:r>
                </a:p>
              </p:txBody>
            </p:sp>
            <p:cxnSp>
              <p:nvCxnSpPr>
                <p:cNvPr id="46" name="Straight Arrow Connector 45">
                  <a:extLst>
                    <a:ext uri="{FF2B5EF4-FFF2-40B4-BE49-F238E27FC236}">
                      <a16:creationId xmlns:a16="http://schemas.microsoft.com/office/drawing/2014/main" id="{DFD02D4F-A364-11F8-2D61-61A1272DB1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2455957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Arrow Connector 46">
                  <a:extLst>
                    <a:ext uri="{FF2B5EF4-FFF2-40B4-BE49-F238E27FC236}">
                      <a16:creationId xmlns:a16="http://schemas.microsoft.com/office/drawing/2014/main" id="{43A3EF1F-B50E-0BEB-677D-88A1EFAE1AB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2885177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Arrow Connector 47">
                  <a:extLst>
                    <a:ext uri="{FF2B5EF4-FFF2-40B4-BE49-F238E27FC236}">
                      <a16:creationId xmlns:a16="http://schemas.microsoft.com/office/drawing/2014/main" id="{0E3D50CD-585A-5FEA-C4B4-688E6EBF0DD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3187399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Arrow Connector 48">
                  <a:extLst>
                    <a:ext uri="{FF2B5EF4-FFF2-40B4-BE49-F238E27FC236}">
                      <a16:creationId xmlns:a16="http://schemas.microsoft.com/office/drawing/2014/main" id="{DCC7C95F-2FC4-85F6-3C12-9C63369740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3442892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Straight Arrow Connector 49">
                  <a:extLst>
                    <a:ext uri="{FF2B5EF4-FFF2-40B4-BE49-F238E27FC236}">
                      <a16:creationId xmlns:a16="http://schemas.microsoft.com/office/drawing/2014/main" id="{5D5D3AB9-E19B-1AE6-72BF-AA00167A3CC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4176648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Arrow Connector 50">
                  <a:extLst>
                    <a:ext uri="{FF2B5EF4-FFF2-40B4-BE49-F238E27FC236}">
                      <a16:creationId xmlns:a16="http://schemas.microsoft.com/office/drawing/2014/main" id="{638713B2-FFE0-FC2C-6435-DDE3100CD7E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3684981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Straight Arrow Connector 51">
                  <a:extLst>
                    <a:ext uri="{FF2B5EF4-FFF2-40B4-BE49-F238E27FC236}">
                      <a16:creationId xmlns:a16="http://schemas.microsoft.com/office/drawing/2014/main" id="{A1EF029D-7B8A-0453-7945-D8FA8C3A0B1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3463" y="4955286"/>
                  <a:ext cx="305909" cy="0"/>
                </a:xfrm>
                <a:prstGeom prst="straightConnector1">
                  <a:avLst/>
                </a:prstGeom>
                <a:ln w="31750">
                  <a:solidFill>
                    <a:schemeClr val="tx1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9D89DD3D-289B-D146-4964-4823016DD0DE}"/>
              </a:ext>
            </a:extLst>
          </p:cNvPr>
          <p:cNvSpPr txBox="1"/>
          <p:nvPr/>
        </p:nvSpPr>
        <p:spPr>
          <a:xfrm>
            <a:off x="570814" y="542260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ung 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BB5FC47-9E7E-9AF2-4D1F-744911B76655}"/>
              </a:ext>
            </a:extLst>
          </p:cNvPr>
          <p:cNvSpPr txBox="1"/>
          <p:nvPr/>
        </p:nvSpPr>
        <p:spPr>
          <a:xfrm>
            <a:off x="2200255" y="2839290"/>
            <a:ext cx="29434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ehicle       SHP2i          </a:t>
            </a:r>
            <a:r>
              <a:rPr lang="en-US" dirty="0" err="1"/>
              <a:t>SHP2i</a:t>
            </a:r>
            <a:endParaRPr lang="en-US" dirty="0"/>
          </a:p>
          <a:p>
            <a:r>
              <a:rPr lang="en-US" dirty="0"/>
              <a:t>                                              +MEKi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0CCA316D-C17C-6492-1D72-D9023DD507F9}"/>
              </a:ext>
            </a:extLst>
          </p:cNvPr>
          <p:cNvCxnSpPr>
            <a:cxnSpLocks/>
          </p:cNvCxnSpPr>
          <p:nvPr/>
        </p:nvCxnSpPr>
        <p:spPr>
          <a:xfrm rot="5400000">
            <a:off x="2812237" y="3686473"/>
            <a:ext cx="776176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12C2C89B-7281-5A15-7B63-3526F8CCB681}"/>
              </a:ext>
            </a:extLst>
          </p:cNvPr>
          <p:cNvCxnSpPr>
            <a:cxnSpLocks/>
          </p:cNvCxnSpPr>
          <p:nvPr/>
        </p:nvCxnSpPr>
        <p:spPr>
          <a:xfrm rot="5400000">
            <a:off x="3894213" y="3686473"/>
            <a:ext cx="776176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0DD7558D-2FDA-EC79-DE7F-2CB312DD59C6}"/>
              </a:ext>
            </a:extLst>
          </p:cNvPr>
          <p:cNvSpPr txBox="1"/>
          <p:nvPr/>
        </p:nvSpPr>
        <p:spPr>
          <a:xfrm>
            <a:off x="3748074" y="1828488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/>
              <a:t>pERK</a:t>
            </a:r>
            <a:endParaRPr lang="en-US" b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68B860A-695B-199D-F7F8-9712C9337802}"/>
              </a:ext>
            </a:extLst>
          </p:cNvPr>
          <p:cNvSpPr txBox="1"/>
          <p:nvPr/>
        </p:nvSpPr>
        <p:spPr>
          <a:xfrm>
            <a:off x="7865981" y="2815193"/>
            <a:ext cx="29434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ehicle       SHP2i          </a:t>
            </a:r>
            <a:r>
              <a:rPr lang="en-US" dirty="0" err="1"/>
              <a:t>SHP2i</a:t>
            </a:r>
            <a:endParaRPr lang="en-US" dirty="0"/>
          </a:p>
          <a:p>
            <a:r>
              <a:rPr lang="en-US" dirty="0"/>
              <a:t>                                              +MEKi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180B142D-EB7B-E437-B18D-AFB7F355C1B1}"/>
              </a:ext>
            </a:extLst>
          </p:cNvPr>
          <p:cNvCxnSpPr>
            <a:cxnSpLocks/>
          </p:cNvCxnSpPr>
          <p:nvPr/>
        </p:nvCxnSpPr>
        <p:spPr>
          <a:xfrm rot="5400000">
            <a:off x="8477963" y="3662376"/>
            <a:ext cx="776176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AF9A30BB-1661-6EAF-5A28-08102EDA27CD}"/>
              </a:ext>
            </a:extLst>
          </p:cNvPr>
          <p:cNvCxnSpPr>
            <a:cxnSpLocks/>
          </p:cNvCxnSpPr>
          <p:nvPr/>
        </p:nvCxnSpPr>
        <p:spPr>
          <a:xfrm rot="5400000">
            <a:off x="9486787" y="3662376"/>
            <a:ext cx="776176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F00A7FFA-EEFD-F585-4062-E44A9B7287EF}"/>
              </a:ext>
            </a:extLst>
          </p:cNvPr>
          <p:cNvCxnSpPr>
            <a:cxnSpLocks/>
          </p:cNvCxnSpPr>
          <p:nvPr/>
        </p:nvCxnSpPr>
        <p:spPr>
          <a:xfrm rot="5400000">
            <a:off x="5125605" y="3686473"/>
            <a:ext cx="776176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FA42DAB7-E012-26EE-BE0B-23B32A6AA78B}"/>
              </a:ext>
            </a:extLst>
          </p:cNvPr>
          <p:cNvCxnSpPr>
            <a:cxnSpLocks/>
          </p:cNvCxnSpPr>
          <p:nvPr/>
        </p:nvCxnSpPr>
        <p:spPr>
          <a:xfrm rot="5400000">
            <a:off x="10663315" y="3662376"/>
            <a:ext cx="776176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48" name="TextBox 2047">
            <a:extLst>
              <a:ext uri="{FF2B5EF4-FFF2-40B4-BE49-F238E27FC236}">
                <a16:creationId xmlns:a16="http://schemas.microsoft.com/office/drawing/2014/main" id="{17BAB909-4E98-1D04-9CD2-519ADD575950}"/>
              </a:ext>
            </a:extLst>
          </p:cNvPr>
          <p:cNvSpPr txBox="1"/>
          <p:nvPr/>
        </p:nvSpPr>
        <p:spPr>
          <a:xfrm>
            <a:off x="9185263" y="1828488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/>
              <a:t>tERK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0681686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80</Words>
  <Application>Microsoft Office PowerPoint</Application>
  <PresentationFormat>Widescreen</PresentationFormat>
  <Paragraphs>5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>Cincinnati Children's Hospit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u, Jianqiang</dc:creator>
  <cp:lastModifiedBy>Wu, Jianqiang</cp:lastModifiedBy>
  <cp:revision>3</cp:revision>
  <dcterms:created xsi:type="dcterms:W3CDTF">2025-09-05T19:29:53Z</dcterms:created>
  <dcterms:modified xsi:type="dcterms:W3CDTF">2025-09-05T20:22:32Z</dcterms:modified>
</cp:coreProperties>
</file>